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1080135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46" autoAdjust="0"/>
    <p:restoredTop sz="94660"/>
  </p:normalViewPr>
  <p:slideViewPr>
    <p:cSldViewPr>
      <p:cViewPr varScale="1">
        <p:scale>
          <a:sx n="50" d="100"/>
          <a:sy n="50" d="100"/>
        </p:scale>
        <p:origin x="2736" y="34"/>
      </p:cViewPr>
      <p:guideLst>
        <p:guide orient="horz" pos="340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F3DF7D-35A5-4E24-9AFC-89C10BF77A18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8025" y="685800"/>
            <a:ext cx="29019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B1E1B0-A4E1-402C-8366-0CAB2C6EC7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439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3355420"/>
            <a:ext cx="7772400" cy="231528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060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791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680086"/>
            <a:ext cx="2057400" cy="14516814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680086"/>
            <a:ext cx="6019800" cy="14516814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152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128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4578074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534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3970497"/>
            <a:ext cx="4038600" cy="112264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3970497"/>
            <a:ext cx="4038600" cy="112264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432555"/>
            <a:ext cx="8229600" cy="1800225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417803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3425428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2417803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3425428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618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006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45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430054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430055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2260283"/>
            <a:ext cx="3008313" cy="73884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8606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458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432555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520316"/>
            <a:ext cx="8229600" cy="71283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10011252"/>
            <a:ext cx="2133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F47C4-5FE9-4337-87CA-5398C32E9BB9}" type="datetimeFigureOut">
              <a:rPr kumimoji="1" lang="ja-JP" altLang="en-US" smtClean="0"/>
              <a:t>2023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10011252"/>
            <a:ext cx="2895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10011252"/>
            <a:ext cx="21336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50D1F-A284-49F9-BFE8-03AE29E53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9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5F2DE6C-EFA7-91F7-D3E2-A0AF5F7A7B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536" y="3168427"/>
            <a:ext cx="8460432" cy="303429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13524E2-408C-D8A8-8370-B0C19A6A886A}"/>
              </a:ext>
            </a:extLst>
          </p:cNvPr>
          <p:cNvSpPr txBox="1"/>
          <p:nvPr/>
        </p:nvSpPr>
        <p:spPr>
          <a:xfrm>
            <a:off x="575048" y="6264771"/>
            <a:ext cx="82809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: Sankey diagrams connecting the initial diagnosis of NMIBC and subsequent pathological pathway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f 990 patients, 236 had at least one instance of bladder cancer recurrence and/or progression. Each vertical bar represents a pathological category: Ta low-grade (LG), Ta high-grade (HG), isolated Tis, and T1HG. The height of the bars is proportional to the number of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URBT, transurethral resection of bladder tumor; WL, conventional white-light; PDD, photodynamic diagnosis-assisted; NMIBC, non-muscle-invasive bladder cancer; UC, urothelial carcinoma.</a:t>
            </a:r>
          </a:p>
        </p:txBody>
      </p:sp>
    </p:spTree>
    <p:extLst>
      <p:ext uri="{BB962C8B-B14F-4D97-AF65-F5344CB8AC3E}">
        <p14:creationId xmlns:p14="http://schemas.microsoft.com/office/powerpoint/2010/main" val="1744314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9</TotalTime>
  <Words>101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User</dc:creator>
  <cp:lastModifiedBy>Miyake Makito</cp:lastModifiedBy>
  <cp:revision>82</cp:revision>
  <dcterms:created xsi:type="dcterms:W3CDTF">2022-07-14T15:14:45Z</dcterms:created>
  <dcterms:modified xsi:type="dcterms:W3CDTF">2023-01-06T19:44:41Z</dcterms:modified>
</cp:coreProperties>
</file>